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3" r:id="rId3"/>
    <p:sldId id="303" r:id="rId4"/>
    <p:sldId id="304" r:id="rId5"/>
    <p:sldId id="297" r:id="rId6"/>
    <p:sldId id="305" r:id="rId7"/>
    <p:sldId id="299" r:id="rId8"/>
    <p:sldId id="306" r:id="rId9"/>
    <p:sldId id="298" r:id="rId1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1386" y="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A00DA-5C10-4E71-9312-B3F7AB2D0F56}" type="datetimeFigureOut">
              <a:rPr lang="en-US" smtClean="0"/>
              <a:pPr/>
              <a:t>5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75062-A23F-4537-BAB5-0A78F7F0EA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A00DA-5C10-4E71-9312-B3F7AB2D0F56}" type="datetimeFigureOut">
              <a:rPr lang="en-US" smtClean="0"/>
              <a:pPr/>
              <a:t>5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75062-A23F-4537-BAB5-0A78F7F0EA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A00DA-5C10-4E71-9312-B3F7AB2D0F56}" type="datetimeFigureOut">
              <a:rPr lang="en-US" smtClean="0"/>
              <a:pPr/>
              <a:t>5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75062-A23F-4537-BAB5-0A78F7F0EA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A00DA-5C10-4E71-9312-B3F7AB2D0F56}" type="datetimeFigureOut">
              <a:rPr lang="en-US" smtClean="0"/>
              <a:pPr/>
              <a:t>5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75062-A23F-4537-BAB5-0A78F7F0EA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A00DA-5C10-4E71-9312-B3F7AB2D0F56}" type="datetimeFigureOut">
              <a:rPr lang="en-US" smtClean="0"/>
              <a:pPr/>
              <a:t>5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75062-A23F-4537-BAB5-0A78F7F0EA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A00DA-5C10-4E71-9312-B3F7AB2D0F56}" type="datetimeFigureOut">
              <a:rPr lang="en-US" smtClean="0"/>
              <a:pPr/>
              <a:t>5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75062-A23F-4537-BAB5-0A78F7F0EA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A00DA-5C10-4E71-9312-B3F7AB2D0F56}" type="datetimeFigureOut">
              <a:rPr lang="en-US" smtClean="0"/>
              <a:pPr/>
              <a:t>5/14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75062-A23F-4537-BAB5-0A78F7F0EA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A00DA-5C10-4E71-9312-B3F7AB2D0F56}" type="datetimeFigureOut">
              <a:rPr lang="en-US" smtClean="0"/>
              <a:pPr/>
              <a:t>5/14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75062-A23F-4537-BAB5-0A78F7F0EA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A00DA-5C10-4E71-9312-B3F7AB2D0F56}" type="datetimeFigureOut">
              <a:rPr lang="en-US" smtClean="0"/>
              <a:pPr/>
              <a:t>5/14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75062-A23F-4537-BAB5-0A78F7F0EA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A00DA-5C10-4E71-9312-B3F7AB2D0F56}" type="datetimeFigureOut">
              <a:rPr lang="en-US" smtClean="0"/>
              <a:pPr/>
              <a:t>5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75062-A23F-4537-BAB5-0A78F7F0EA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A00DA-5C10-4E71-9312-B3F7AB2D0F56}" type="datetimeFigureOut">
              <a:rPr lang="en-US" smtClean="0"/>
              <a:pPr/>
              <a:t>5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675062-A23F-4537-BAB5-0A78F7F0EA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9A00DA-5C10-4E71-9312-B3F7AB2D0F56}" type="datetimeFigureOut">
              <a:rPr lang="en-US" smtClean="0"/>
              <a:pPr/>
              <a:t>5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675062-A23F-4537-BAB5-0A78F7F0EAC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QTL Cartographer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 smtClean="0"/>
              <a:t>QTL Analysis for </a:t>
            </a:r>
            <a:r>
              <a:rPr lang="en-US" dirty="0" err="1" smtClean="0"/>
              <a:t>Bittergourd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0"/>
            <a:ext cx="8229600" cy="1143000"/>
          </a:xfrm>
        </p:spPr>
        <p:txBody>
          <a:bodyPr/>
          <a:lstStyle/>
          <a:p>
            <a:r>
              <a:rPr lang="en-US" dirty="0" smtClean="0"/>
              <a:t>QTL parameters</a:t>
            </a:r>
            <a:endParaRPr lang="en-US" dirty="0"/>
          </a:p>
        </p:txBody>
      </p:sp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 cstate="print"/>
          <a:srcRect l="26940" t="17708" r="27379" b="31250"/>
          <a:stretch>
            <a:fillRect/>
          </a:stretch>
        </p:blipFill>
        <p:spPr bwMode="auto">
          <a:xfrm>
            <a:off x="1676400" y="3124200"/>
            <a:ext cx="5943600" cy="3733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171" name="Picture 3"/>
          <p:cNvPicPr>
            <a:picLocks noChangeAspect="1" noChangeArrowheads="1"/>
          </p:cNvPicPr>
          <p:nvPr/>
        </p:nvPicPr>
        <p:blipFill>
          <a:blip r:embed="rId3" cstate="print"/>
          <a:srcRect l="16032" t="7292" r="33602" b="64583"/>
          <a:stretch>
            <a:fillRect/>
          </a:stretch>
        </p:blipFill>
        <p:spPr bwMode="auto">
          <a:xfrm>
            <a:off x="1219200" y="990600"/>
            <a:ext cx="6553200" cy="2057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457200" y="0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lvl="0" algn="ctr">
              <a:spcBef>
                <a:spcPct val="0"/>
              </a:spcBef>
              <a:defRPr/>
            </a:pPr>
            <a:r>
              <a:rPr lang="en-IN" sz="4400" b="1" dirty="0" err="1" smtClean="0"/>
              <a:t>Gynoecious</a:t>
            </a:r>
            <a:r>
              <a:rPr lang="en-IN" sz="4400" b="1" dirty="0" smtClean="0"/>
              <a:t> in F2</a:t>
            </a:r>
            <a:endParaRPr kumimoji="0" lang="en-US" sz="4400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2286000"/>
            <a:ext cx="9144000" cy="457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24399690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457200" y="0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lvl="0" algn="ctr">
              <a:spcBef>
                <a:spcPct val="0"/>
              </a:spcBef>
              <a:defRPr/>
            </a:pPr>
            <a:r>
              <a:rPr lang="en-IN" sz="4400" b="1" dirty="0"/>
              <a:t>1st Female </a:t>
            </a:r>
            <a:r>
              <a:rPr lang="en-IN" sz="4400" b="1" dirty="0" smtClean="0"/>
              <a:t>node </a:t>
            </a:r>
            <a:r>
              <a:rPr lang="en-IN" sz="4400" b="1" dirty="0"/>
              <a:t>in</a:t>
            </a:r>
            <a:r>
              <a:rPr lang="en-IN" sz="4400" b="1" dirty="0" smtClean="0"/>
              <a:t> F2</a:t>
            </a:r>
            <a:endParaRPr kumimoji="0" lang="en-US" sz="4400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2286000"/>
            <a:ext cx="9144000" cy="457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2470263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457200" y="0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lvl="0" algn="ctr">
              <a:spcBef>
                <a:spcPct val="0"/>
              </a:spcBef>
              <a:defRPr/>
            </a:pPr>
            <a:r>
              <a:rPr lang="en-IN" sz="4400" b="1" dirty="0"/>
              <a:t>1st Female </a:t>
            </a:r>
            <a:r>
              <a:rPr lang="en-IN" sz="4400" b="1" dirty="0" smtClean="0"/>
              <a:t>node in F3</a:t>
            </a:r>
            <a:endParaRPr kumimoji="0" lang="en-US" sz="4400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2286000"/>
            <a:ext cx="9144000" cy="457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457200" y="0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lvl="0" algn="ctr">
              <a:spcBef>
                <a:spcPct val="0"/>
              </a:spcBef>
              <a:defRPr/>
            </a:pPr>
            <a:r>
              <a:rPr lang="en-IN" sz="4400" b="1" dirty="0"/>
              <a:t>1st Female </a:t>
            </a:r>
            <a:r>
              <a:rPr lang="en-IN" sz="4400" b="1" dirty="0" smtClean="0"/>
              <a:t>day </a:t>
            </a:r>
            <a:r>
              <a:rPr lang="en-IN" sz="4400" b="1" dirty="0"/>
              <a:t>in</a:t>
            </a:r>
            <a:r>
              <a:rPr lang="en-IN" sz="4400" b="1" dirty="0" smtClean="0"/>
              <a:t> F2</a:t>
            </a:r>
            <a:endParaRPr kumimoji="0" lang="en-US" sz="4400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2286000"/>
            <a:ext cx="9144000" cy="457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24549112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457200" y="0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lvl="0" algn="ctr">
              <a:spcBef>
                <a:spcPct val="0"/>
              </a:spcBef>
              <a:defRPr/>
            </a:pPr>
            <a:r>
              <a:rPr lang="en-IN" sz="4400" b="1" dirty="0"/>
              <a:t>1st Female </a:t>
            </a:r>
            <a:r>
              <a:rPr lang="en-IN" sz="4400" b="1" dirty="0" smtClean="0"/>
              <a:t>day in F3</a:t>
            </a:r>
            <a:endParaRPr kumimoji="0" lang="en-US" sz="4400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pic>
        <p:nvPicPr>
          <p:cNvPr id="3584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2286000"/>
            <a:ext cx="9144000" cy="457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457200" y="0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lvl="0" algn="ctr">
              <a:spcBef>
                <a:spcPct val="0"/>
              </a:spcBef>
              <a:defRPr/>
            </a:pPr>
            <a:r>
              <a:rPr lang="en-IN" sz="4400" b="1" dirty="0"/>
              <a:t>sex ratio (</a:t>
            </a:r>
            <a:r>
              <a:rPr lang="en-IN" sz="4400" b="1" dirty="0" err="1"/>
              <a:t>male:female</a:t>
            </a:r>
            <a:r>
              <a:rPr lang="en-IN" sz="4400" b="1" dirty="0" smtClean="0"/>
              <a:t>) </a:t>
            </a:r>
            <a:r>
              <a:rPr lang="en-IN" sz="4400" b="1" dirty="0"/>
              <a:t>in</a:t>
            </a:r>
            <a:r>
              <a:rPr lang="en-IN" sz="4400" b="1" dirty="0" smtClean="0"/>
              <a:t> F2</a:t>
            </a:r>
            <a:endParaRPr kumimoji="0" lang="en-US" sz="4400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2286000"/>
            <a:ext cx="9144000" cy="457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37565639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457200" y="0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lvl="0" algn="ctr">
              <a:spcBef>
                <a:spcPct val="0"/>
              </a:spcBef>
              <a:defRPr/>
            </a:pPr>
            <a:r>
              <a:rPr lang="en-IN" sz="4400" b="1" dirty="0"/>
              <a:t>sex ratio (</a:t>
            </a:r>
            <a:r>
              <a:rPr lang="en-IN" sz="4400" b="1" dirty="0" err="1"/>
              <a:t>male:female</a:t>
            </a:r>
            <a:r>
              <a:rPr lang="en-IN" sz="4400" b="1" smtClean="0"/>
              <a:t>) </a:t>
            </a:r>
            <a:r>
              <a:rPr lang="en-IN" sz="4400" b="1"/>
              <a:t>in</a:t>
            </a:r>
            <a:r>
              <a:rPr lang="en-IN" sz="4400" b="1" smtClean="0"/>
              <a:t> </a:t>
            </a:r>
            <a:r>
              <a:rPr lang="en-IN" sz="4400" b="1" dirty="0" smtClean="0"/>
              <a:t>F3</a:t>
            </a:r>
            <a:endParaRPr kumimoji="0" lang="en-US" sz="4400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pic>
        <p:nvPicPr>
          <p:cNvPr id="3686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2286000"/>
            <a:ext cx="9144000" cy="457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6</TotalTime>
  <Words>45</Words>
  <Application>Microsoft Office PowerPoint</Application>
  <PresentationFormat>On-screen Show (4:3)</PresentationFormat>
  <Paragraphs>10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2" baseType="lpstr">
      <vt:lpstr>Arial</vt:lpstr>
      <vt:lpstr>Calibri</vt:lpstr>
      <vt:lpstr>Office Theme</vt:lpstr>
      <vt:lpstr>QTL Cartographer</vt:lpstr>
      <vt:lpstr>QTL parameter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QTL Cartographer</dc:title>
  <dc:creator>Rakesh Maurya</dc:creator>
  <cp:lastModifiedBy>ADMIN</cp:lastModifiedBy>
  <cp:revision>16</cp:revision>
  <dcterms:created xsi:type="dcterms:W3CDTF">2016-10-09T19:47:18Z</dcterms:created>
  <dcterms:modified xsi:type="dcterms:W3CDTF">2018-05-14T17:16:23Z</dcterms:modified>
</cp:coreProperties>
</file>